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30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92B37F44-6ACC-6B40-BF04-DA8B1325E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5956" y="639612"/>
            <a:ext cx="4265154" cy="512256"/>
          </a:xfrm>
        </p:spPr>
        <p:txBody>
          <a:bodyPr>
            <a:noAutofit/>
          </a:bodyPr>
          <a:lstStyle/>
          <a:p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Supplemental Table 1: Patient demographics in the second line patient cohort. 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E94FE5B-0D34-C449-9E85-AEBE3A9E9E93}"/>
              </a:ext>
            </a:extLst>
          </p:cNvPr>
          <p:cNvGraphicFramePr>
            <a:graphicFrameLocks noGrp="1"/>
          </p:cNvGraphicFramePr>
          <p:nvPr/>
        </p:nvGraphicFramePr>
        <p:xfrm>
          <a:off x="7110247" y="446643"/>
          <a:ext cx="4564119" cy="5964714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605265">
                  <a:extLst>
                    <a:ext uri="{9D8B030D-6E8A-4147-A177-3AD203B41FA5}">
                      <a16:colId xmlns:a16="http://schemas.microsoft.com/office/drawing/2014/main" val="2605288687"/>
                    </a:ext>
                  </a:extLst>
                </a:gridCol>
                <a:gridCol w="789028">
                  <a:extLst>
                    <a:ext uri="{9D8B030D-6E8A-4147-A177-3AD203B41FA5}">
                      <a16:colId xmlns:a16="http://schemas.microsoft.com/office/drawing/2014/main" val="3459802550"/>
                    </a:ext>
                  </a:extLst>
                </a:gridCol>
                <a:gridCol w="789028">
                  <a:extLst>
                    <a:ext uri="{9D8B030D-6E8A-4147-A177-3AD203B41FA5}">
                      <a16:colId xmlns:a16="http://schemas.microsoft.com/office/drawing/2014/main" val="2173571015"/>
                    </a:ext>
                  </a:extLst>
                </a:gridCol>
                <a:gridCol w="789028">
                  <a:extLst>
                    <a:ext uri="{9D8B030D-6E8A-4147-A177-3AD203B41FA5}">
                      <a16:colId xmlns:a16="http://schemas.microsoft.com/office/drawing/2014/main" val="1257750646"/>
                    </a:ext>
                  </a:extLst>
                </a:gridCol>
                <a:gridCol w="591770">
                  <a:extLst>
                    <a:ext uri="{9D8B030D-6E8A-4147-A177-3AD203B41FA5}">
                      <a16:colId xmlns:a16="http://schemas.microsoft.com/office/drawing/2014/main" val="1915292751"/>
                    </a:ext>
                  </a:extLst>
                </a:gridCol>
              </a:tblGrid>
              <a:tr h="69069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Chemo (N=263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ICPI (N=99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Total (N=362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p valu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571361541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Age at Dx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559845617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edian (Q1, Q3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5.0 (55.0, 71.5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8.0 (57.5, 74.0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5.0 (56.0, 72.0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647578635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Sex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637218834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F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0 (26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7 (27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97 (26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563326405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93 (73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2 (72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65 (73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550011929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Rac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46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546367987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African America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4 (5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 (4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8 (5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399621888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European America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83 (69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4 (64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47 (68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93170685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Other or Unknow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6 (25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1 (31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97 (26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736632036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actice Typ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18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518144905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Academi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8 (6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1 (11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9 (8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328286320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ommunity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45 (93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8 (88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33 (92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576374532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Site of Primary Tumo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7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15030204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Esophagea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95 (36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4 (34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29 (35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968291245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Gastri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92 (35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2 (32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24 (34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634484922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Gastroesophageal Junction (GEJ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6 (28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3 (33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9 (30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622198042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Stage at Dx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4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331906759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Stage I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 (1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 (1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 (1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514832570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Stage II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4 (5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 (10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4 (6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64100095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Stage III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2 (12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4 (14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6 (12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4047318319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Stage IV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81 (68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1 (61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42 (66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4217866387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Unknown/not documente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1 (11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3 (13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4 (12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425643209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History of Smokin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391439884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History of smokin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79 (68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6 (66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45 (67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641169764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 history of smokin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4 (31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3 (33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17 (32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269241452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or Surgery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2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11916008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04 (77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1 (71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75 (76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266543867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Ye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9 (22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8 (28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7 (24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460792972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CO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45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343074920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 (0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 (0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 (0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606090454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6 (26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1 (23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7 (26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493569404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34 (54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6 (51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80 (53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532097080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3+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4 (17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2 (24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6 (19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989970924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issing Observation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960804037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HER2 IH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86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747032947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egativ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23 (84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6 (86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09 (85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925191708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Positiv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7 (6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 (6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3 (6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295074309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unknow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3 (8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 (7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0 (8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253808976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TM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&lt; 0.0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074249643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edian (Q1, Q3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.5 (1.7, 6.1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.0 (2.5, 9.2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.8 (1.7, 6.3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681433015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MSI by NG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&lt; 0.0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166538322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SI unknow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7 (25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7 (17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4 (23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972729428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SI-H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 (1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6 (16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1 (5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516900634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S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91 (72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6 (66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57 (71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557810465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D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&lt; 0.0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211256166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PS 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6 (13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 (10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6 (12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681459819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PS 1-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4 (12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3 (13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7 (13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010231198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PS 10+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7 (14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7 (27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4 (17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059522540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PS 5-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9 (7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6 (16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5 (9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842091210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unknow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37 (52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3 (33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70 (47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4281835113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Album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96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174372712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Below LL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3 (33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2 (33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15 (33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164406828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rma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68 (66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4 (66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32 (66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154978591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issing Observation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103504017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ilirub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79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1745507301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Above UL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8 (7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 (6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4 (7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4176293196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rma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24 (92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5 (93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09 (92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730775901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issing Observation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349992903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5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744902200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Above UL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1 (8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 (10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1 (8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2598470471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rma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29 (91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7 (89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16 (91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989876104"/>
                  </a:ext>
                </a:extLst>
              </a:tr>
              <a:tr h="6906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issing Observation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38" marR="3238" marT="3238" marB="0" anchor="b"/>
                </a:tc>
                <a:extLst>
                  <a:ext uri="{0D108BD9-81ED-4DB2-BD59-A6C34878D82A}">
                    <a16:rowId xmlns:a16="http://schemas.microsoft.com/office/drawing/2014/main" val="3094928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45725841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43</Words>
  <Application>Microsoft Macintosh PowerPoint</Application>
  <PresentationFormat>Widescreen</PresentationFormat>
  <Paragraphs>2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Table 1: Patient demographics in the second line patient cohort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3</cp:revision>
  <dcterms:created xsi:type="dcterms:W3CDTF">2022-06-12T16:24:02Z</dcterms:created>
  <dcterms:modified xsi:type="dcterms:W3CDTF">2022-06-27T19:50:07Z</dcterms:modified>
</cp:coreProperties>
</file>